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</p:sldIdLst>
  <p:sldSz cx="12192000" cy="97202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386" autoAdjust="0"/>
    <p:restoredTop sz="96327"/>
  </p:normalViewPr>
  <p:slideViewPr>
    <p:cSldViewPr snapToGrid="0">
      <p:cViewPr varScale="1">
        <p:scale>
          <a:sx n="87" d="100"/>
          <a:sy n="87" d="100"/>
        </p:scale>
        <p:origin x="2120" y="208"/>
      </p:cViewPr>
      <p:guideLst/>
    </p:cSldViewPr>
  </p:slideViewPr>
  <p:notesTextViewPr>
    <p:cViewPr>
      <p:scale>
        <a:sx n="33" d="100"/>
        <a:sy n="33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OANNIS CHATZIEFFRAIMIDIS" userId="b961d053ce115571" providerId="LiveId" clId="{EEE8EA51-0644-4221-A89F-49C2277D6B76}"/>
    <pc:docChg chg="undo custSel modSld">
      <pc:chgData name="IOANNIS CHATZIEFFRAIMIDIS" userId="b961d053ce115571" providerId="LiveId" clId="{EEE8EA51-0644-4221-A89F-49C2277D6B76}" dt="2025-11-09T18:19:38.990" v="41" actId="404"/>
      <pc:docMkLst>
        <pc:docMk/>
      </pc:docMkLst>
      <pc:sldChg chg="addSp modSp mod">
        <pc:chgData name="IOANNIS CHATZIEFFRAIMIDIS" userId="b961d053ce115571" providerId="LiveId" clId="{EEE8EA51-0644-4221-A89F-49C2277D6B76}" dt="2025-11-09T18:19:38.990" v="41" actId="404"/>
        <pc:sldMkLst>
          <pc:docMk/>
          <pc:sldMk cId="3530030011" sldId="272"/>
        </pc:sldMkLst>
        <pc:spChg chg="add mod">
          <ac:chgData name="IOANNIS CHATZIEFFRAIMIDIS" userId="b961d053ce115571" providerId="LiveId" clId="{EEE8EA51-0644-4221-A89F-49C2277D6B76}" dt="2025-11-09T18:19:38.990" v="41" actId="404"/>
          <ac:spMkLst>
            <pc:docMk/>
            <pc:sldMk cId="3530030011" sldId="272"/>
            <ac:spMk id="3" creationId="{3AFB7DC4-2873-D6D8-18A2-DD3115BA12B8}"/>
          </ac:spMkLst>
        </pc:spChg>
        <pc:spChg chg="add mod">
          <ac:chgData name="IOANNIS CHATZIEFFRAIMIDIS" userId="b961d053ce115571" providerId="LiveId" clId="{EEE8EA51-0644-4221-A89F-49C2277D6B76}" dt="2025-11-09T18:19:27.083" v="40" actId="14100"/>
          <ac:spMkLst>
            <pc:docMk/>
            <pc:sldMk cId="3530030011" sldId="272"/>
            <ac:spMk id="6" creationId="{A1EB36B3-4ACE-729D-5B3B-8099D82DC9CA}"/>
          </ac:spMkLst>
        </pc:spChg>
        <pc:grpChg chg="mod">
          <ac:chgData name="IOANNIS CHATZIEFFRAIMIDIS" userId="b961d053ce115571" providerId="LiveId" clId="{EEE8EA51-0644-4221-A89F-49C2277D6B76}" dt="2025-11-09T18:18:00.544" v="31" actId="1076"/>
          <ac:grpSpMkLst>
            <pc:docMk/>
            <pc:sldMk cId="3530030011" sldId="272"/>
            <ac:grpSpMk id="9" creationId="{838ADE00-0A0D-E616-CBBC-6A9FE699F7E5}"/>
          </ac:grpSpMkLst>
        </pc:grpChg>
        <pc:grpChg chg="mod">
          <ac:chgData name="IOANNIS CHATZIEFFRAIMIDIS" userId="b961d053ce115571" providerId="LiveId" clId="{EEE8EA51-0644-4221-A89F-49C2277D6B76}" dt="2025-11-09T18:18:00.544" v="31" actId="1076"/>
          <ac:grpSpMkLst>
            <pc:docMk/>
            <pc:sldMk cId="3530030011" sldId="272"/>
            <ac:grpSpMk id="12" creationId="{F5C38DDC-CDE6-C99E-2056-8C7BF4B15B22}"/>
          </ac:grpSpMkLst>
        </pc:grpChg>
        <pc:picChg chg="mod">
          <ac:chgData name="IOANNIS CHATZIEFFRAIMIDIS" userId="b961d053ce115571" providerId="LiveId" clId="{EEE8EA51-0644-4221-A89F-49C2277D6B76}" dt="2025-11-09T18:18:00.544" v="31" actId="1076"/>
          <ac:picMkLst>
            <pc:docMk/>
            <pc:sldMk cId="3530030011" sldId="272"/>
            <ac:picMk id="11" creationId="{D99A0A28-CE2B-ACB2-59AD-72707F01BD35}"/>
          </ac:picMkLst>
        </pc:picChg>
        <pc:picChg chg="mod">
          <ac:chgData name="IOANNIS CHATZIEFFRAIMIDIS" userId="b961d053ce115571" providerId="LiveId" clId="{EEE8EA51-0644-4221-A89F-49C2277D6B76}" dt="2025-11-09T18:18:00.544" v="31" actId="1076"/>
          <ac:picMkLst>
            <pc:docMk/>
            <pc:sldMk cId="3530030011" sldId="272"/>
            <ac:picMk id="14" creationId="{CE214EBF-A9B0-B9FF-5CFD-36394B51A934}"/>
          </ac:picMkLst>
        </pc:picChg>
        <pc:picChg chg="mod">
          <ac:chgData name="IOANNIS CHATZIEFFRAIMIDIS" userId="b961d053ce115571" providerId="LiveId" clId="{EEE8EA51-0644-4221-A89F-49C2277D6B76}" dt="2025-11-09T18:18:00.544" v="31" actId="1076"/>
          <ac:picMkLst>
            <pc:docMk/>
            <pc:sldMk cId="3530030011" sldId="272"/>
            <ac:picMk id="21" creationId="{5D023DC2-D951-1FD1-4003-6F661CA5EE14}"/>
          </ac:picMkLst>
        </pc:picChg>
        <pc:picChg chg="mod">
          <ac:chgData name="IOANNIS CHATZIEFFRAIMIDIS" userId="b961d053ce115571" providerId="LiveId" clId="{EEE8EA51-0644-4221-A89F-49C2277D6B76}" dt="2025-11-09T18:18:00.544" v="31" actId="1076"/>
          <ac:picMkLst>
            <pc:docMk/>
            <pc:sldMk cId="3530030011" sldId="272"/>
            <ac:picMk id="23" creationId="{45DB3903-1062-C0F2-1573-10FDA3860FDD}"/>
          </ac:picMkLst>
        </pc:picChg>
        <pc:picChg chg="mod">
          <ac:chgData name="IOANNIS CHATZIEFFRAIMIDIS" userId="b961d053ce115571" providerId="LiveId" clId="{EEE8EA51-0644-4221-A89F-49C2277D6B76}" dt="2025-11-09T18:18:00.544" v="31" actId="1076"/>
          <ac:picMkLst>
            <pc:docMk/>
            <pc:sldMk cId="3530030011" sldId="272"/>
            <ac:picMk id="30" creationId="{3161FB61-FF96-921E-EF94-7C99CF8400B9}"/>
          </ac:picMkLst>
        </pc:picChg>
        <pc:picChg chg="mod">
          <ac:chgData name="IOANNIS CHATZIEFFRAIMIDIS" userId="b961d053ce115571" providerId="LiveId" clId="{EEE8EA51-0644-4221-A89F-49C2277D6B76}" dt="2025-11-09T18:18:00.544" v="31" actId="1076"/>
          <ac:picMkLst>
            <pc:docMk/>
            <pc:sldMk cId="3530030011" sldId="272"/>
            <ac:picMk id="31" creationId="{D9A499D4-169D-FB42-C077-A8A7E0AD2B2E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590794"/>
            <a:ext cx="10363200" cy="338409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105389"/>
            <a:ext cx="9144000" cy="234681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73122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81940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17514"/>
            <a:ext cx="2628900" cy="8237474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17514"/>
            <a:ext cx="7734300" cy="8237474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416041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049663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423318"/>
            <a:ext cx="10515600" cy="404335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504929"/>
            <a:ext cx="10515600" cy="2126307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9031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587570"/>
            <a:ext cx="5181600" cy="616741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587570"/>
            <a:ext cx="5181600" cy="616741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555451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17516"/>
            <a:ext cx="10515600" cy="1878802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382815"/>
            <a:ext cx="5157787" cy="116778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550596"/>
            <a:ext cx="5157787" cy="5222392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382815"/>
            <a:ext cx="5183188" cy="116778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550596"/>
            <a:ext cx="5183188" cy="5222392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5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55275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5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78698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5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558305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48018"/>
            <a:ext cx="3932237" cy="2268061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99540"/>
            <a:ext cx="6172200" cy="690768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916079"/>
            <a:ext cx="3932237" cy="540239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739833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48018"/>
            <a:ext cx="3932237" cy="2268061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99540"/>
            <a:ext cx="6172200" cy="690768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l-GR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916079"/>
            <a:ext cx="3932237" cy="540239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8431937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17516"/>
            <a:ext cx="10515600" cy="1878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587570"/>
            <a:ext cx="10515600" cy="61674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9009246"/>
            <a:ext cx="274320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C63F7-925C-41A1-BB4A-0E79ED06C004}" type="datetimeFigureOut">
              <a:rPr lang="el-GR" smtClean="0"/>
              <a:t>20/11/2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9009246"/>
            <a:ext cx="411480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9009246"/>
            <a:ext cx="274320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6296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Ομάδα 1">
            <a:extLst>
              <a:ext uri="{FF2B5EF4-FFF2-40B4-BE49-F238E27FC236}">
                <a16:creationId xmlns:a16="http://schemas.microsoft.com/office/drawing/2014/main" id="{C3A00C81-B437-6988-F6C1-DD1AB423CE45}"/>
              </a:ext>
            </a:extLst>
          </p:cNvPr>
          <p:cNvGrpSpPr/>
          <p:nvPr/>
        </p:nvGrpSpPr>
        <p:grpSpPr>
          <a:xfrm>
            <a:off x="2354438" y="2873943"/>
            <a:ext cx="3904627" cy="2716830"/>
            <a:chOff x="3139126" y="674463"/>
            <a:chExt cx="3904627" cy="2716830"/>
          </a:xfrm>
        </p:grpSpPr>
        <p:pic>
          <p:nvPicPr>
            <p:cNvPr id="4" name="Εικόνα 3">
              <a:extLst>
                <a:ext uri="{FF2B5EF4-FFF2-40B4-BE49-F238E27FC236}">
                  <a16:creationId xmlns:a16="http://schemas.microsoft.com/office/drawing/2014/main" id="{1ACC6B85-C86C-894E-9A1D-FEA46CA5DEF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r="90911"/>
            <a:stretch>
              <a:fillRect/>
            </a:stretch>
          </p:blipFill>
          <p:spPr>
            <a:xfrm>
              <a:off x="3139126" y="674463"/>
              <a:ext cx="320511" cy="2716830"/>
            </a:xfrm>
            <a:prstGeom prst="rect">
              <a:avLst/>
            </a:prstGeom>
          </p:spPr>
        </p:pic>
        <p:pic>
          <p:nvPicPr>
            <p:cNvPr id="13" name="Εικόνα 12">
              <a:extLst>
                <a:ext uri="{FF2B5EF4-FFF2-40B4-BE49-F238E27FC236}">
                  <a16:creationId xmlns:a16="http://schemas.microsoft.com/office/drawing/2014/main" id="{76579B9F-B8D9-E20D-C962-70301BCF217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64154" y="806309"/>
              <a:ext cx="3579599" cy="2563233"/>
            </a:xfrm>
            <a:prstGeom prst="rect">
              <a:avLst/>
            </a:prstGeom>
          </p:spPr>
        </p:pic>
      </p:grpSp>
      <p:pic>
        <p:nvPicPr>
          <p:cNvPr id="15" name="Εικόνα 14">
            <a:extLst>
              <a:ext uri="{FF2B5EF4-FFF2-40B4-BE49-F238E27FC236}">
                <a16:creationId xmlns:a16="http://schemas.microsoft.com/office/drawing/2014/main" id="{D9003015-010F-E2AA-7AF0-A436257A8F9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15671" y="2749035"/>
            <a:ext cx="1362992" cy="288846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16" name="Εικόνα 15">
            <a:extLst>
              <a:ext uri="{FF2B5EF4-FFF2-40B4-BE49-F238E27FC236}">
                <a16:creationId xmlns:a16="http://schemas.microsoft.com/office/drawing/2014/main" id="{EE7734E2-E5EA-C8D6-8ACF-19B5350EA5D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22119" y="2497837"/>
            <a:ext cx="1322258" cy="274154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17" name="Εικόνα 16">
            <a:extLst>
              <a:ext uri="{FF2B5EF4-FFF2-40B4-BE49-F238E27FC236}">
                <a16:creationId xmlns:a16="http://schemas.microsoft.com/office/drawing/2014/main" id="{E3603EA6-CB9A-FA5D-CC9F-C68FEC17F54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42172" y="2525549"/>
            <a:ext cx="966593" cy="215869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18" name="Εικόνα 17">
            <a:extLst>
              <a:ext uri="{FF2B5EF4-FFF2-40B4-BE49-F238E27FC236}">
                <a16:creationId xmlns:a16="http://schemas.microsoft.com/office/drawing/2014/main" id="{4FBFA11B-E0C0-B42B-5124-BCA079ABF6C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35405" y="2734631"/>
            <a:ext cx="1028025" cy="2543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</p:pic>
      <p:pic>
        <p:nvPicPr>
          <p:cNvPr id="19" name="Εικόνα 18">
            <a:extLst>
              <a:ext uri="{FF2B5EF4-FFF2-40B4-BE49-F238E27FC236}">
                <a16:creationId xmlns:a16="http://schemas.microsoft.com/office/drawing/2014/main" id="{CB946523-A7D3-9E33-E4D7-332FE3E3FEC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153361" y="3061305"/>
            <a:ext cx="3442506" cy="2515909"/>
          </a:xfrm>
          <a:prstGeom prst="rect">
            <a:avLst/>
          </a:prstGeom>
        </p:spPr>
      </p:pic>
      <p:grpSp>
        <p:nvGrpSpPr>
          <p:cNvPr id="20" name="Ομάδα 19">
            <a:extLst>
              <a:ext uri="{FF2B5EF4-FFF2-40B4-BE49-F238E27FC236}">
                <a16:creationId xmlns:a16="http://schemas.microsoft.com/office/drawing/2014/main" id="{B569791B-B3AF-4258-BF73-AD3EC412A64F}"/>
              </a:ext>
            </a:extLst>
          </p:cNvPr>
          <p:cNvGrpSpPr/>
          <p:nvPr/>
        </p:nvGrpSpPr>
        <p:grpSpPr>
          <a:xfrm>
            <a:off x="2345012" y="5116806"/>
            <a:ext cx="3921814" cy="2629919"/>
            <a:chOff x="3176834" y="3803317"/>
            <a:chExt cx="3836973" cy="2616436"/>
          </a:xfrm>
        </p:grpSpPr>
        <p:pic>
          <p:nvPicPr>
            <p:cNvPr id="22" name="Εικόνα 21">
              <a:extLst>
                <a:ext uri="{FF2B5EF4-FFF2-40B4-BE49-F238E27FC236}">
                  <a16:creationId xmlns:a16="http://schemas.microsoft.com/office/drawing/2014/main" id="{1CC033F4-07A2-DC79-24FE-B9AEB95A720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rcRect r="91046"/>
            <a:stretch>
              <a:fillRect/>
            </a:stretch>
          </p:blipFill>
          <p:spPr>
            <a:xfrm>
              <a:off x="3176834" y="3805198"/>
              <a:ext cx="320511" cy="2614555"/>
            </a:xfrm>
            <a:prstGeom prst="rect">
              <a:avLst/>
            </a:prstGeom>
          </p:spPr>
        </p:pic>
        <p:pic>
          <p:nvPicPr>
            <p:cNvPr id="24" name="Εικόνα 23">
              <a:extLst>
                <a:ext uri="{FF2B5EF4-FFF2-40B4-BE49-F238E27FC236}">
                  <a16:creationId xmlns:a16="http://schemas.microsoft.com/office/drawing/2014/main" id="{8DFD4A2E-BD01-542B-6C9F-311DAE4F1CC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492897" y="3803317"/>
              <a:ext cx="3520910" cy="2515910"/>
            </a:xfrm>
            <a:prstGeom prst="rect">
              <a:avLst/>
            </a:prstGeom>
          </p:spPr>
        </p:pic>
      </p:grpSp>
      <p:pic>
        <p:nvPicPr>
          <p:cNvPr id="25" name="Εικόνα 24">
            <a:extLst>
              <a:ext uri="{FF2B5EF4-FFF2-40B4-BE49-F238E27FC236}">
                <a16:creationId xmlns:a16="http://schemas.microsoft.com/office/drawing/2014/main" id="{31D3B8FF-DB56-736F-E4B9-010D3F7CD64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162319" y="5095751"/>
            <a:ext cx="3442505" cy="259727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15E692E1-ED7F-8D45-62C0-388997F9326E}"/>
              </a:ext>
            </a:extLst>
          </p:cNvPr>
          <p:cNvSpPr txBox="1"/>
          <p:nvPr/>
        </p:nvSpPr>
        <p:spPr>
          <a:xfrm>
            <a:off x="33657" y="12002"/>
            <a:ext cx="12084553" cy="13724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600"/>
              </a:spcAft>
              <a:buNone/>
            </a:pPr>
            <a:r>
              <a:rPr lang="en-US" b="1" dirty="0">
                <a:effectLst/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Plants</a:t>
            </a:r>
          </a:p>
          <a:p>
            <a:pPr algn="just">
              <a:lnSpc>
                <a:spcPct val="115000"/>
              </a:lnSpc>
              <a:spcAft>
                <a:spcPts val="600"/>
              </a:spcAft>
              <a:buNone/>
            </a:pPr>
            <a:r>
              <a:rPr lang="en-US" b="1" dirty="0">
                <a:effectLst/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Canopy design drives photosynthetic performance, light environment, and fruit quality in peach (</a:t>
            </a:r>
            <a:r>
              <a:rPr lang="en-US" b="1" i="1" dirty="0">
                <a:effectLst/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Prunus persica</a:t>
            </a:r>
            <a:r>
              <a:rPr lang="en-US" b="1" dirty="0">
                <a:effectLst/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 L. Batsch)</a:t>
            </a:r>
            <a:endParaRPr lang="el-GR" sz="1200" dirty="0">
              <a:effectLst/>
              <a:latin typeface="Palatino Linotype" panose="0204050205050503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600"/>
              </a:spcAft>
              <a:buNone/>
            </a:pPr>
            <a:endParaRPr lang="en-US" sz="1050" dirty="0">
              <a:effectLst/>
              <a:latin typeface="Palatino Linotype" panose="0204050205050503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946A13B-5059-F54D-57D9-C976BC1B5B74}"/>
              </a:ext>
            </a:extLst>
          </p:cNvPr>
          <p:cNvSpPr txBox="1"/>
          <p:nvPr/>
        </p:nvSpPr>
        <p:spPr>
          <a:xfrm>
            <a:off x="33657" y="1096866"/>
            <a:ext cx="12084553" cy="11503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600"/>
              </a:spcAft>
              <a:buNone/>
            </a:pPr>
            <a:r>
              <a:rPr lang="en-US" dirty="0">
                <a:effectLst/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Ioannis Chatzieffraimidis, Dimos Stouris, Marina-Rafailia Kyrou, Fokion Papathanasiou, Evangelos Karagiannis*</a:t>
            </a:r>
            <a:endParaRPr lang="el-GR" sz="1400" dirty="0">
              <a:effectLst/>
              <a:latin typeface="Palatino Linotype" panose="0204050205050503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600"/>
              </a:spcAft>
              <a:buNone/>
            </a:pPr>
            <a:r>
              <a:rPr lang="en-US" i="1" dirty="0">
                <a:effectLst/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Department of </a:t>
            </a:r>
            <a:r>
              <a:rPr lang="en-US" i="1" dirty="0"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Agriculture, School of Agricultural Sciences, </a:t>
            </a:r>
            <a:r>
              <a:rPr lang="en-US" i="1" dirty="0">
                <a:effectLst/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University of Western Macedonia, 53100 Florina, Greece</a:t>
            </a:r>
            <a:endParaRPr lang="el-GR" sz="1400" dirty="0">
              <a:effectLst/>
              <a:latin typeface="Palatino Linotype" panose="0204050205050503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600"/>
              </a:spcAft>
              <a:buNone/>
            </a:pPr>
            <a:r>
              <a:rPr lang="en-US" sz="1600" dirty="0">
                <a:effectLst/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																   *Corresponding Author: ekaragiannis@uowm.gr</a:t>
            </a:r>
            <a:r>
              <a:rPr lang="en-US" sz="105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endParaRPr lang="el-GR" dirty="0">
              <a:latin typeface="Palatino Linotype" panose="0204050205050503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2C4B060-33B9-487C-ED45-CF373522AB30}"/>
              </a:ext>
            </a:extLst>
          </p:cNvPr>
          <p:cNvSpPr txBox="1"/>
          <p:nvPr/>
        </p:nvSpPr>
        <p:spPr>
          <a:xfrm>
            <a:off x="154238" y="7811885"/>
            <a:ext cx="11750887" cy="15647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600"/>
              </a:spcAft>
              <a:buNone/>
            </a:pPr>
            <a:r>
              <a:rPr lang="en-US" sz="1400" b="1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ure S</a:t>
            </a:r>
            <a:r>
              <a:rPr lang="en-US" sz="1400" b="1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1:</a:t>
            </a:r>
            <a:r>
              <a:rPr lang="en-US" sz="14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Intra-canopy light environment in </a:t>
            </a:r>
            <a:r>
              <a:rPr lang="en-US" sz="1400" i="1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runus persica</a:t>
            </a:r>
            <a:r>
              <a:rPr lang="en-US" sz="14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vs</a:t>
            </a:r>
            <a:r>
              <a:rPr lang="en-US" sz="14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‘</a:t>
            </a:r>
            <a:r>
              <a:rPr lang="en-US" sz="1400" dirty="0" err="1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latibelle</a:t>
            </a:r>
            <a:r>
              <a:rPr lang="en-US" sz="14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 and ‘Mirel’ trained to two canopy architectures, a planar two-dimensional (Four-Axes, green) and a three-dimensional (Quad-V, orange) system, during the 2023 and 2024 growing seasons. Photosynthetic photon flux density (PPFD, </a:t>
            </a:r>
            <a:r>
              <a:rPr lang="en-US" sz="1400" dirty="0" err="1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μmol</a:t>
            </a:r>
            <a:r>
              <a:rPr lang="en-US" sz="14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m⁻² s⁻¹) and relative light availability (%) were measured at representative positions within the lower (L) and upper (H) canopy zones at pit hardening (PH) and harvest (H). Data represent mean values ± SE (n = 4) for each training system and canopy zone. Asterisks denote significant differences between training systems or canopy zones (* </a:t>
            </a:r>
            <a:r>
              <a:rPr lang="en-US" sz="1400" i="1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&lt; 0.05</a:t>
            </a:r>
            <a:r>
              <a:rPr lang="en-US" sz="14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; ** </a:t>
            </a:r>
            <a:r>
              <a:rPr lang="en-US" sz="1400" i="1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&lt; 0.01</a:t>
            </a:r>
            <a:r>
              <a:rPr lang="en-US" sz="14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; *** </a:t>
            </a:r>
            <a:r>
              <a:rPr lang="en-US" sz="1400" i="1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&lt; 0.001</a:t>
            </a:r>
            <a:r>
              <a:rPr lang="en-US" sz="14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; ns = not significant; ANOVA followed by Duncan’s multiple range test). </a:t>
            </a:r>
            <a:endParaRPr lang="el-GR" sz="1600" dirty="0">
              <a:effectLst/>
              <a:latin typeface="Palatino Linotype" panose="0204050205050503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0030011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Office 2013 - 2022">
  <a:themeElements>
    <a:clrScheme name="Θέμα Office 2013 - 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Office 2013 - 2022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Office 2013 - 2022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</TotalTime>
  <Words>237</Words>
  <Application>Microsoft Macintosh PowerPoint</Application>
  <PresentationFormat>Προσαρμογή</PresentationFormat>
  <Paragraphs>6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4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Θέμα Office 2013 - 2022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OANNIS CHATZIEFFRAIMIDIS</dc:creator>
  <cp:lastModifiedBy>ΚΑΡΑΓΙΑΝΝΗΣ ΕΥΑΓΓΕΛΟΣ</cp:lastModifiedBy>
  <cp:revision>4</cp:revision>
  <dcterms:created xsi:type="dcterms:W3CDTF">2025-11-05T20:47:40Z</dcterms:created>
  <dcterms:modified xsi:type="dcterms:W3CDTF">2025-11-20T10:23:35Z</dcterms:modified>
</cp:coreProperties>
</file>